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81800" cy="99187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E77F48-42A3-4906-A3F4-4A40C3EB5CC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4C4D3E-6FFC-41A7-B41A-9A3A1A462C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F12863-8D9E-430A-A945-7E8D235A3FA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0B1D0C-CA92-40AE-930E-22991548A16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1D600B-F760-48F3-918E-084B4171998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396676-8DC7-43E6-8471-063FFE076AD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FB41A0-35A4-422F-B9F5-3C208BC4D0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6B7185-FD3D-4712-A250-B8C0A90EF0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26D4D1-9F23-4759-A5A3-12A28ADF7E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DA82D7-231C-400D-ACD7-BDD3525E46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9DE34E-1918-496B-AAC9-7C5FA4C6DB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BC19E6-3F9F-4B21-8DAD-49D5415B06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1F4E056-72C8-4EA9-A71C-7CC92BDA029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784520" y="263520"/>
            <a:ext cx="53989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784520" y="263520"/>
            <a:ext cx="5398920" cy="1947960"/>
          </a:xfrm>
          <a:prstGeom prst="rect">
            <a:avLst/>
          </a:prstGeom>
          <a:noFill/>
          <a:ln w="93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784520" y="263520"/>
            <a:ext cx="0" cy="19479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730520" y="2211480"/>
            <a:ext cx="54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730520" y="1879560"/>
            <a:ext cx="54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730520" y="1562040"/>
            <a:ext cx="54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730520" y="1230480"/>
            <a:ext cx="54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730520" y="911160"/>
            <a:ext cx="54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730520" y="581040"/>
            <a:ext cx="54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730520" y="263520"/>
            <a:ext cx="54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784520" y="2211480"/>
            <a:ext cx="53989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flipV="1">
            <a:off x="1784520" y="2211120"/>
            <a:ext cx="0" cy="601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3320" bIns="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flipV="1">
            <a:off x="2685960" y="2211120"/>
            <a:ext cx="0" cy="601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3320" bIns="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flipV="1">
            <a:off x="3584520" y="2211120"/>
            <a:ext cx="0" cy="601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3320" bIns="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flipV="1">
            <a:off x="4484520" y="2211120"/>
            <a:ext cx="0" cy="601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3320" bIns="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flipV="1">
            <a:off x="5384880" y="2211120"/>
            <a:ext cx="0" cy="601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3320" bIns="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flipV="1">
            <a:off x="6283440" y="2211120"/>
            <a:ext cx="0" cy="601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3320" bIns="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 flipV="1">
            <a:off x="7183440" y="2211120"/>
            <a:ext cx="0" cy="601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3320" bIns="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4484520" y="1335240"/>
            <a:ext cx="82800" cy="9036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5492880" y="927000"/>
            <a:ext cx="82440" cy="9216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5970600" y="685800"/>
            <a:ext cx="81000" cy="9036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733920" y="1365120"/>
            <a:ext cx="82440" cy="907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038400" y="1562040"/>
            <a:ext cx="82800" cy="907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893960" y="2165400"/>
            <a:ext cx="82440" cy="9216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4675320" y="1289160"/>
            <a:ext cx="82440" cy="9180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1771560" y="2165400"/>
            <a:ext cx="81000" cy="9216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4552920" y="1397160"/>
            <a:ext cx="82440" cy="889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5029200" y="1260360"/>
            <a:ext cx="82440" cy="889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5289480" y="941400"/>
            <a:ext cx="81000" cy="9216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5084640" y="1260360"/>
            <a:ext cx="82800" cy="889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4103640" y="1486080"/>
            <a:ext cx="81000" cy="9180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4743360" y="1230480"/>
            <a:ext cx="82800" cy="8856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1760" bIns="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4226040" y="1170000"/>
            <a:ext cx="81000" cy="9036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4402080" y="1515960"/>
            <a:ext cx="82440" cy="9216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f13341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1757520" y="2165400"/>
            <a:ext cx="82440" cy="9216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3313080" y="1743120"/>
            <a:ext cx="81000" cy="9036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3067200" y="1712880"/>
            <a:ext cx="80640" cy="9036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2506680" y="1893960"/>
            <a:ext cx="82440" cy="9216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4184640" y="1380960"/>
            <a:ext cx="81000" cy="907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2154240" y="1849320"/>
            <a:ext cx="81000" cy="889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2139840" y="1938240"/>
            <a:ext cx="82800" cy="9216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2930400" y="1849320"/>
            <a:ext cx="81000" cy="889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2876400" y="1986120"/>
            <a:ext cx="81000" cy="889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3679920" y="1697040"/>
            <a:ext cx="81000" cy="9216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3340080" y="1682640"/>
            <a:ext cx="81000" cy="907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4457880" y="1274760"/>
            <a:ext cx="82440" cy="9036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3052800" y="1757520"/>
            <a:ext cx="81000" cy="9180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3489480" y="1562040"/>
            <a:ext cx="82440" cy="907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3830760" y="1592280"/>
            <a:ext cx="82440" cy="9036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4089240" y="1441440"/>
            <a:ext cx="81000" cy="889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3886200" y="1530360"/>
            <a:ext cx="81000" cy="9216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2371680" y="2120760"/>
            <a:ext cx="81000" cy="907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3898800" y="1638360"/>
            <a:ext cx="81000" cy="889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2494080" y="2151000"/>
            <a:ext cx="81000" cy="907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2181240" y="2044800"/>
            <a:ext cx="81000" cy="9036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2835360" y="1863720"/>
            <a:ext cx="81000" cy="9036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3408480" y="1592280"/>
            <a:ext cx="81000" cy="9036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3925800" y="1546200"/>
            <a:ext cx="82800" cy="9216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3133800" y="1592280"/>
            <a:ext cx="84240" cy="9036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5207040" y="1184400"/>
            <a:ext cx="82440" cy="9036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3760920" y="1397160"/>
            <a:ext cx="83880" cy="889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4457880" y="1349280"/>
            <a:ext cx="82440" cy="9216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6516720" y="581040"/>
            <a:ext cx="81000" cy="889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3584520" y="1515960"/>
            <a:ext cx="81000" cy="9216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96dce6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4838760" y="1077840"/>
            <a:ext cx="81000" cy="9216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3489480" y="1501920"/>
            <a:ext cx="82440" cy="9036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3774960" y="1515960"/>
            <a:ext cx="82800" cy="9216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3886200" y="1365120"/>
            <a:ext cx="81000" cy="907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3133800" y="1608120"/>
            <a:ext cx="84240" cy="889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5683320" y="806400"/>
            <a:ext cx="84240" cy="9036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1830240" y="665280"/>
            <a:ext cx="4757760" cy="1525320"/>
          </a:xfrm>
          <a:custGeom>
            <a:avLst/>
            <a:gdLst/>
            <a:ahLst/>
            <a:rect l="l" t="t" r="r" b="b"/>
            <a:pathLst>
              <a:path w="349" h="101">
                <a:moveTo>
                  <a:pt x="0" y="101"/>
                </a:moveTo>
                <a:lnTo>
                  <a:pt x="6" y="100"/>
                </a:lnTo>
                <a:lnTo>
                  <a:pt x="12" y="98"/>
                </a:lnTo>
                <a:lnTo>
                  <a:pt x="18" y="96"/>
                </a:lnTo>
                <a:lnTo>
                  <a:pt x="24" y="94"/>
                </a:lnTo>
                <a:lnTo>
                  <a:pt x="30" y="93"/>
                </a:lnTo>
                <a:lnTo>
                  <a:pt x="36" y="91"/>
                </a:lnTo>
                <a:lnTo>
                  <a:pt x="42" y="89"/>
                </a:lnTo>
                <a:lnTo>
                  <a:pt x="48" y="87"/>
                </a:lnTo>
                <a:lnTo>
                  <a:pt x="54" y="86"/>
                </a:lnTo>
                <a:lnTo>
                  <a:pt x="60" y="84"/>
                </a:lnTo>
                <a:lnTo>
                  <a:pt x="66" y="82"/>
                </a:lnTo>
                <a:lnTo>
                  <a:pt x="72" y="80"/>
                </a:lnTo>
                <a:lnTo>
                  <a:pt x="78" y="79"/>
                </a:lnTo>
                <a:lnTo>
                  <a:pt x="84" y="77"/>
                </a:lnTo>
                <a:lnTo>
                  <a:pt x="90" y="75"/>
                </a:lnTo>
                <a:lnTo>
                  <a:pt x="96" y="73"/>
                </a:lnTo>
                <a:lnTo>
                  <a:pt x="102" y="72"/>
                </a:lnTo>
                <a:lnTo>
                  <a:pt x="108" y="70"/>
                </a:lnTo>
                <a:lnTo>
                  <a:pt x="114" y="68"/>
                </a:lnTo>
                <a:lnTo>
                  <a:pt x="120" y="66"/>
                </a:lnTo>
                <a:lnTo>
                  <a:pt x="126" y="65"/>
                </a:lnTo>
                <a:lnTo>
                  <a:pt x="132" y="63"/>
                </a:lnTo>
                <a:lnTo>
                  <a:pt x="138" y="61"/>
                </a:lnTo>
                <a:lnTo>
                  <a:pt x="144" y="59"/>
                </a:lnTo>
                <a:lnTo>
                  <a:pt x="150" y="58"/>
                </a:lnTo>
                <a:lnTo>
                  <a:pt x="156" y="56"/>
                </a:lnTo>
                <a:lnTo>
                  <a:pt x="162" y="54"/>
                </a:lnTo>
                <a:lnTo>
                  <a:pt x="168" y="52"/>
                </a:lnTo>
                <a:lnTo>
                  <a:pt x="174" y="51"/>
                </a:lnTo>
                <a:lnTo>
                  <a:pt x="180" y="49"/>
                </a:lnTo>
                <a:lnTo>
                  <a:pt x="186" y="47"/>
                </a:lnTo>
                <a:lnTo>
                  <a:pt x="192" y="45"/>
                </a:lnTo>
                <a:lnTo>
                  <a:pt x="198" y="44"/>
                </a:lnTo>
                <a:lnTo>
                  <a:pt x="204" y="42"/>
                </a:lnTo>
                <a:lnTo>
                  <a:pt x="210" y="40"/>
                </a:lnTo>
                <a:lnTo>
                  <a:pt x="216" y="38"/>
                </a:lnTo>
                <a:lnTo>
                  <a:pt x="222" y="37"/>
                </a:lnTo>
                <a:lnTo>
                  <a:pt x="228" y="35"/>
                </a:lnTo>
                <a:lnTo>
                  <a:pt x="234" y="33"/>
                </a:lnTo>
                <a:lnTo>
                  <a:pt x="240" y="31"/>
                </a:lnTo>
                <a:lnTo>
                  <a:pt x="247" y="30"/>
                </a:lnTo>
                <a:lnTo>
                  <a:pt x="253" y="28"/>
                </a:lnTo>
                <a:lnTo>
                  <a:pt x="259" y="26"/>
                </a:lnTo>
                <a:lnTo>
                  <a:pt x="265" y="24"/>
                </a:lnTo>
                <a:lnTo>
                  <a:pt x="271" y="23"/>
                </a:lnTo>
                <a:lnTo>
                  <a:pt x="277" y="21"/>
                </a:lnTo>
                <a:lnTo>
                  <a:pt x="283" y="19"/>
                </a:lnTo>
                <a:lnTo>
                  <a:pt x="289" y="17"/>
                </a:lnTo>
                <a:lnTo>
                  <a:pt x="295" y="16"/>
                </a:lnTo>
                <a:lnTo>
                  <a:pt x="301" y="14"/>
                </a:lnTo>
                <a:lnTo>
                  <a:pt x="307" y="12"/>
                </a:lnTo>
                <a:lnTo>
                  <a:pt x="313" y="10"/>
                </a:lnTo>
                <a:lnTo>
                  <a:pt x="319" y="9"/>
                </a:lnTo>
                <a:lnTo>
                  <a:pt x="325" y="7"/>
                </a:lnTo>
                <a:lnTo>
                  <a:pt x="331" y="5"/>
                </a:lnTo>
                <a:lnTo>
                  <a:pt x="337" y="4"/>
                </a:lnTo>
                <a:lnTo>
                  <a:pt x="343" y="2"/>
                </a:lnTo>
                <a:lnTo>
                  <a:pt x="349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2" name=""/>
          <p:cNvGrpSpPr/>
          <p:nvPr/>
        </p:nvGrpSpPr>
        <p:grpSpPr>
          <a:xfrm>
            <a:off x="1899360" y="290520"/>
            <a:ext cx="722160" cy="182520"/>
            <a:chOff x="1899360" y="290520"/>
            <a:chExt cx="722160" cy="182520"/>
          </a:xfrm>
        </p:grpSpPr>
        <p:sp>
          <p:nvSpPr>
            <p:cNvPr id="113" name=""/>
            <p:cNvSpPr/>
            <p:nvPr/>
          </p:nvSpPr>
          <p:spPr>
            <a:xfrm>
              <a:off x="1899360" y="320400"/>
              <a:ext cx="92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2024640" y="2905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2091960" y="320400"/>
              <a:ext cx="529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= 0.913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6" name=""/>
          <p:cNvSpPr/>
          <p:nvPr/>
        </p:nvSpPr>
        <p:spPr>
          <a:xfrm>
            <a:off x="1618920" y="212400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1526400" y="179064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1526400" y="14749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1526400" y="114156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1526400" y="82548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1526400" y="4921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1526400" y="17460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1741680" y="227664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2561400" y="227664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3461760" y="227664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4360320" y="227664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5261760" y="227664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6160320" y="227664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7060680" y="227664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1910880" y="479520"/>
            <a:ext cx="669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 &lt; 0.0000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3822840" y="2468520"/>
            <a:ext cx="1280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log (FMR1ex3.4/GU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 rot="16200000">
            <a:off x="629280" y="1178640"/>
            <a:ext cx="1491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log (FMR1ex13.1.4/GUS)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3" name="" descr=""/>
          <p:cNvPicPr/>
          <p:nvPr/>
        </p:nvPicPr>
        <p:blipFill>
          <a:blip r:embed="rId1"/>
          <a:stretch/>
        </p:blipFill>
        <p:spPr>
          <a:xfrm>
            <a:off x="4286160" y="2701800"/>
            <a:ext cx="2816280" cy="1214640"/>
          </a:xfrm>
          <a:prstGeom prst="rect">
            <a:avLst/>
          </a:prstGeom>
          <a:ln w="0">
            <a:noFill/>
          </a:ln>
        </p:spPr>
      </p:pic>
      <p:pic>
        <p:nvPicPr>
          <p:cNvPr id="134" name="" descr=""/>
          <p:cNvPicPr/>
          <p:nvPr/>
        </p:nvPicPr>
        <p:blipFill>
          <a:blip r:embed="rId2"/>
          <a:stretch/>
        </p:blipFill>
        <p:spPr>
          <a:xfrm>
            <a:off x="4286160" y="3948120"/>
            <a:ext cx="2816280" cy="1312920"/>
          </a:xfrm>
          <a:prstGeom prst="rect">
            <a:avLst/>
          </a:prstGeom>
          <a:ln w="0">
            <a:noFill/>
          </a:ln>
        </p:spPr>
      </p:pic>
      <p:sp>
        <p:nvSpPr>
          <p:cNvPr id="135" name=""/>
          <p:cNvSpPr/>
          <p:nvPr/>
        </p:nvSpPr>
        <p:spPr>
          <a:xfrm>
            <a:off x="1258920" y="149400"/>
            <a:ext cx="177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(A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1295280" y="2637000"/>
            <a:ext cx="181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(B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4506840" y="2714760"/>
            <a:ext cx="1800" cy="15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4579200" y="274644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0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4563360" y="405936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4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0" name="" descr=""/>
          <p:cNvPicPr/>
          <p:nvPr/>
        </p:nvPicPr>
        <p:blipFill>
          <a:blip r:embed="rId3"/>
          <a:stretch/>
        </p:blipFill>
        <p:spPr>
          <a:xfrm>
            <a:off x="1471680" y="2701800"/>
            <a:ext cx="2741400" cy="1181160"/>
          </a:xfrm>
          <a:prstGeom prst="rect">
            <a:avLst/>
          </a:prstGeom>
          <a:ln w="0">
            <a:noFill/>
          </a:ln>
        </p:spPr>
      </p:pic>
      <p:sp>
        <p:nvSpPr>
          <p:cNvPr id="141" name=""/>
          <p:cNvSpPr/>
          <p:nvPr/>
        </p:nvSpPr>
        <p:spPr>
          <a:xfrm>
            <a:off x="1258920" y="2685960"/>
            <a:ext cx="1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2" name="" descr=""/>
          <p:cNvPicPr/>
          <p:nvPr/>
        </p:nvPicPr>
        <p:blipFill>
          <a:blip r:embed="rId4"/>
          <a:stretch/>
        </p:blipFill>
        <p:spPr>
          <a:xfrm>
            <a:off x="1471680" y="3948120"/>
            <a:ext cx="2741400" cy="1312920"/>
          </a:xfrm>
          <a:prstGeom prst="rect">
            <a:avLst/>
          </a:prstGeom>
          <a:ln w="0">
            <a:noFill/>
          </a:ln>
        </p:spPr>
      </p:pic>
      <p:sp>
        <p:nvSpPr>
          <p:cNvPr id="143" name=""/>
          <p:cNvSpPr/>
          <p:nvPr/>
        </p:nvSpPr>
        <p:spPr>
          <a:xfrm>
            <a:off x="1759680" y="405936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0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1759680" y="274644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1616040" y="2766960"/>
            <a:ext cx="82440" cy="907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99cc0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4457880" y="2779560"/>
            <a:ext cx="80640" cy="907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f13341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3298680" y="1682640"/>
            <a:ext cx="82800" cy="907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d15bc9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3325680" y="1622520"/>
            <a:ext cx="82800" cy="9036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99cc0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1614600" y="4054320"/>
            <a:ext cx="82440" cy="907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d15bc9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4429080" y="4092480"/>
            <a:ext cx="82440" cy="907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96dce6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3254760" y="2768760"/>
            <a:ext cx="87696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8S:18S – 2.6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QI – 1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6119640" y="2768760"/>
            <a:ext cx="89568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8S:18S – 1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QI – 9.9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2941560" y="4014720"/>
            <a:ext cx="118440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8S:18S – 2.5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QI – 1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5829480" y="4035600"/>
            <a:ext cx="118584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8S:18S – 2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QI – 1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1330200" y="5299920"/>
            <a:ext cx="612144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Arial"/>
              </a:rPr>
              <a:t>Additional file 1.</a:t>
            </a:r>
            <a:r>
              <a:rPr b="0" i="1" lang="en-AU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i="1" lang="en-AU" sz="1200" spc="-1" strike="noStrike">
                <a:solidFill>
                  <a:srgbClr val="000000"/>
                </a:solidFill>
                <a:latin typeface="Arial"/>
              </a:rPr>
              <a:t>FMR1ex3.4</a:t>
            </a:r>
            <a:r>
              <a:rPr b="1" lang="en-AU" sz="12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1" i="1" lang="en-AU" sz="1200" spc="-1" strike="noStrike">
                <a:solidFill>
                  <a:srgbClr val="000000"/>
                </a:solidFill>
                <a:latin typeface="Arial"/>
              </a:rPr>
              <a:t>FMR1ex13.14</a:t>
            </a:r>
            <a:r>
              <a:rPr b="1" lang="en-AU" sz="1200" spc="-1" strike="noStrike">
                <a:solidFill>
                  <a:srgbClr val="000000"/>
                </a:solidFill>
                <a:latin typeface="Arial"/>
              </a:rPr>
              <a:t> assays detect transcripts of a similar abundance in peripheral blood of patients (n=54) with small to intermediate size expansions in RNA samples of high total RNA quality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</a:rPr>
              <a:t> (A) Relationship between qPCR results for </a:t>
            </a:r>
            <a:r>
              <a:rPr b="0" i="1" lang="en-AU" sz="1200" spc="-1" strike="noStrike">
                <a:solidFill>
                  <a:srgbClr val="000000"/>
                </a:solidFill>
                <a:latin typeface="Arial"/>
              </a:rPr>
              <a:t>FMR1ex3.4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</a:rPr>
              <a:t> (x axis) and </a:t>
            </a:r>
            <a:r>
              <a:rPr b="0" i="1" lang="en-AU" sz="1200" spc="-1" strike="noStrike">
                <a:solidFill>
                  <a:srgbClr val="000000"/>
                </a:solidFill>
                <a:latin typeface="Arial"/>
              </a:rPr>
              <a:t>FMR1ex13.14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</a:rPr>
              <a:t> assays (y axis) standardized to </a:t>
            </a:r>
            <a:r>
              <a:rPr b="0" i="1" lang="en-AU" sz="1200" spc="-1" strike="noStrike">
                <a:solidFill>
                  <a:srgbClr val="000000"/>
                </a:solidFill>
                <a:latin typeface="Arial"/>
              </a:rPr>
              <a:t>GUS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</a:rPr>
              <a:t> in patient blood (B) Chromatographs, 28S:18S and RQI values for color coded samples (each dot of the same color represents the same sample in A)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6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9-15T03:26:46Z</dcterms:created>
  <dc:creator>david.godler</dc:creator>
  <dc:description/>
  <dc:language>en-US</dc:language>
  <cp:lastModifiedBy>david.godler</cp:lastModifiedBy>
  <dcterms:modified xsi:type="dcterms:W3CDTF">2009-05-29T08:21:57Z</dcterms:modified>
  <cp:revision>19</cp:revision>
  <dc:subject/>
  <dc:title>Slide 1</dc:title>
</cp:coreProperties>
</file>